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92" d="100"/>
          <a:sy n="92" d="100"/>
        </p:scale>
        <p:origin x="341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urya Krishna Sakthivel" userId="b86613fe-285c-4821-9c8f-8ad655ced490" providerId="ADAL" clId="{886AAC4F-527D-4FBC-BC34-48F4B6FC8233}"/>
    <pc:docChg chg="modSld">
      <pc:chgData name="Surya Krishna Sakthivel" userId="b86613fe-285c-4821-9c8f-8ad655ced490" providerId="ADAL" clId="{886AAC4F-527D-4FBC-BC34-48F4B6FC8233}" dt="2025-11-09T21:12:32.114" v="11" actId="403"/>
      <pc:docMkLst>
        <pc:docMk/>
      </pc:docMkLst>
      <pc:sldChg chg="modSp mod">
        <pc:chgData name="Surya Krishna Sakthivel" userId="b86613fe-285c-4821-9c8f-8ad655ced490" providerId="ADAL" clId="{886AAC4F-527D-4FBC-BC34-48F4B6FC8233}" dt="2025-11-09T21:12:32.114" v="11" actId="403"/>
        <pc:sldMkLst>
          <pc:docMk/>
          <pc:sldMk cId="1524359778" sldId="257"/>
        </pc:sldMkLst>
        <pc:spChg chg="mod">
          <ac:chgData name="Surya Krishna Sakthivel" userId="b86613fe-285c-4821-9c8f-8ad655ced490" providerId="ADAL" clId="{886AAC4F-527D-4FBC-BC34-48F4B6FC8233}" dt="2025-11-09T21:11:55.333" v="5" actId="6549"/>
          <ac:spMkLst>
            <pc:docMk/>
            <pc:sldMk cId="1524359778" sldId="257"/>
            <ac:spMk id="5" creationId="{EC8BFB5D-8D9E-B2FC-9774-EF4CBD4764A3}"/>
          </ac:spMkLst>
        </pc:spChg>
        <pc:spChg chg="mod">
          <ac:chgData name="Surya Krishna Sakthivel" userId="b86613fe-285c-4821-9c8f-8ad655ced490" providerId="ADAL" clId="{886AAC4F-527D-4FBC-BC34-48F4B6FC8233}" dt="2025-11-09T21:12:32.114" v="11" actId="403"/>
          <ac:spMkLst>
            <pc:docMk/>
            <pc:sldMk cId="1524359778" sldId="257"/>
            <ac:spMk id="7" creationId="{BE6C5839-8953-F957-4B1C-5CC45A44261B}"/>
          </ac:spMkLst>
        </pc:spChg>
      </pc:sldChg>
      <pc:sldChg chg="modSp mod">
        <pc:chgData name="Surya Krishna Sakthivel" userId="b86613fe-285c-4821-9c8f-8ad655ced490" providerId="ADAL" clId="{886AAC4F-527D-4FBC-BC34-48F4B6FC8233}" dt="2025-11-09T21:12:14.139" v="9" actId="14100"/>
        <pc:sldMkLst>
          <pc:docMk/>
          <pc:sldMk cId="4041057707" sldId="258"/>
        </pc:sldMkLst>
        <pc:spChg chg="mod">
          <ac:chgData name="Surya Krishna Sakthivel" userId="b86613fe-285c-4821-9c8f-8ad655ced490" providerId="ADAL" clId="{886AAC4F-527D-4FBC-BC34-48F4B6FC8233}" dt="2025-11-09T21:12:14.139" v="9" actId="14100"/>
          <ac:spMkLst>
            <pc:docMk/>
            <pc:sldMk cId="4041057707" sldId="258"/>
            <ac:spMk id="9" creationId="{56B6B46F-7A18-15C5-6313-D8E2917FB8A3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8E2B7B-D9E7-F74F-7731-C7C9D0C1E3B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9515ACD-27DB-2033-D5EF-14BEB3924F2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BC5C92-4715-5C63-E1B1-731A3E9997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8FF0F-D9FB-4F84-88CC-17AFF4F7237A}" type="datetimeFigureOut">
              <a:rPr lang="en-US" smtClean="0"/>
              <a:t>11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44BBE3-066B-B16E-6ECB-3307D4A7EF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19B703-48E4-991E-18C1-62E8C5E7AC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47CCC-67F3-4C5D-9090-5B6C25D661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28632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532E20-605A-CE07-0874-1939AAABDC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AD02912-471F-84A5-80DA-2965805048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35997E-86D4-B2D6-D620-F4C3F68BA0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8FF0F-D9FB-4F84-88CC-17AFF4F7237A}" type="datetimeFigureOut">
              <a:rPr lang="en-US" smtClean="0"/>
              <a:t>11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70F1B1-595F-CFE7-FFFD-B967236B5A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A10B8D-9C05-616E-A028-5D8BAA4CE5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47CCC-67F3-4C5D-9090-5B6C25D661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58005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9867E6C-B2E4-724E-1ED0-D203D435B49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4CEBB25-5BD0-1072-BAB8-B454D00CD63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7AE76A-AC7D-EA52-732B-7C8F50CAE6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8FF0F-D9FB-4F84-88CC-17AFF4F7237A}" type="datetimeFigureOut">
              <a:rPr lang="en-US" smtClean="0"/>
              <a:t>11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78A0B4-4413-8367-6C5E-FD9C5F5B05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9255A2-91C6-C895-2FDC-71010A6A24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47CCC-67F3-4C5D-9090-5B6C25D661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08295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40B19C-64D6-EDAB-7B0D-3CFD474467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4CB2CF8-57AA-E609-3F5C-A5D872A8408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1BC0F9-2D0E-19E4-1F21-C5BE97FC36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8FF0F-D9FB-4F84-88CC-17AFF4F7237A}" type="datetimeFigureOut">
              <a:rPr lang="en-US" smtClean="0"/>
              <a:t>11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311528-4FD5-EB94-11CD-11CA3D683C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7ECF2C-89FE-F5D8-95BA-98F41CBFF9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47CCC-67F3-4C5D-9090-5B6C25D661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35544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42B706-69C1-8803-EC55-A115E9741D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4BE11D6-0540-57D7-9E7F-D78466E8A4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320A9E-657D-4C1E-8254-0ADFCE6FD4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8FF0F-D9FB-4F84-88CC-17AFF4F7237A}" type="datetimeFigureOut">
              <a:rPr lang="en-US" smtClean="0"/>
              <a:t>11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4DC551-CAA1-2793-D888-CA7E10E822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E38C8E-AFF1-504D-954F-730113EACF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47CCC-67F3-4C5D-9090-5B6C25D661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10299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77595B-8E04-1915-EC29-C056DE0265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C2A78FD-0804-0653-7DB7-8CE6BA64375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33C6BF4-3CF8-800C-BD97-BA659477A25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4EE3F47-EEC9-A8A7-B86E-665A1D28EE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8FF0F-D9FB-4F84-88CC-17AFF4F7237A}" type="datetimeFigureOut">
              <a:rPr lang="en-US" smtClean="0"/>
              <a:t>11/1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690C468-4B3E-67DD-C34A-903140BF00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C4B3C45-D192-941D-BEF2-9A88F712CF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47CCC-67F3-4C5D-9090-5B6C25D661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41795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5179EB-DFE2-3CF3-2D78-4A1D99EF07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B6F5457-5407-1B0E-D700-C6E2CA9917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184D5CB-A3CA-F4D0-9B10-3BA7E66E5B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A58D7E4-96E3-7355-0242-79186FE371A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1FD54E0-C019-D081-8193-0A638C9412F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ACC075F-0759-E02F-BF45-65C3C80D00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8FF0F-D9FB-4F84-88CC-17AFF4F7237A}" type="datetimeFigureOut">
              <a:rPr lang="en-US" smtClean="0"/>
              <a:t>11/10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6C755EF-A0E8-BD8A-F9AF-DA23CB882E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DA607B1-A126-DB1C-393B-AE5E058735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47CCC-67F3-4C5D-9090-5B6C25D661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65359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C971B6-9D22-84BA-924F-05B4A1325E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76EFB96-1C5D-B89B-5136-DE7CD77E6D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8FF0F-D9FB-4F84-88CC-17AFF4F7237A}" type="datetimeFigureOut">
              <a:rPr lang="en-US" smtClean="0"/>
              <a:t>11/10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59DFA72-31EA-7A3B-AC3E-80211EEDAC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AD29321-C9EE-6D86-7256-743D198C2F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47CCC-67F3-4C5D-9090-5B6C25D661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42567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9D6C97D-6556-F589-CE36-CB862E39DC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8FF0F-D9FB-4F84-88CC-17AFF4F7237A}" type="datetimeFigureOut">
              <a:rPr lang="en-US" smtClean="0"/>
              <a:t>11/10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8C65485-DA2B-D5A9-BEEC-D4CF884E91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2205F80-771E-EE61-5995-7243E4F64B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47CCC-67F3-4C5D-9090-5B6C25D661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62671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8F68E4-3758-3227-E227-DC1C240DC9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09EF6A-8EAA-1E25-E1CB-09783690D8A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EC8C776-52AB-3E83-3F10-30A780322D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665B49-634F-FDA1-A817-F5DD7CEFC4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8FF0F-D9FB-4F84-88CC-17AFF4F7237A}" type="datetimeFigureOut">
              <a:rPr lang="en-US" smtClean="0"/>
              <a:t>11/1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B426002-E64C-F272-ED1C-CCD7B85E6C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7B4790C-6D4C-E2C7-F5A2-3020318415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47CCC-67F3-4C5D-9090-5B6C25D661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2837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1E271B-B31D-2C1A-DFAC-FC3A2B5BFC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0C9215D-11BF-9227-9022-AB1959ACAC5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B3474F4-5B9F-B009-BF61-6072A89F82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A45A466-E638-4EAA-570B-778898F4F4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8FF0F-D9FB-4F84-88CC-17AFF4F7237A}" type="datetimeFigureOut">
              <a:rPr lang="en-US" smtClean="0"/>
              <a:t>11/1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830DBDC-E862-DDEE-05D2-50DA97B866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FEE8487-0F17-46C3-4786-D048A508C5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47CCC-67F3-4C5D-9090-5B6C25D661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43787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F5C217A-E330-A657-9972-3575474AA8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E68587E-F85F-6026-D53D-B811ECFFF5E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720161-006A-822E-E8AB-47FBCDFF609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2E8FF0F-D9FB-4F84-88CC-17AFF4F7237A}" type="datetimeFigureOut">
              <a:rPr lang="en-US" smtClean="0"/>
              <a:t>11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C48FD3-78E7-D10E-FDAB-7763ADFAF9D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F617C3-9EEC-D617-A016-56DF38AE93C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C747CCC-67F3-4C5D-9090-5B6C25D661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21180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test&#10;&#10;AI-generated content may be incorrect.">
            <a:extLst>
              <a:ext uri="{FF2B5EF4-FFF2-40B4-BE49-F238E27FC236}">
                <a16:creationId xmlns:a16="http://schemas.microsoft.com/office/drawing/2014/main" id="{38749364-DB25-25A0-0F14-A4F021213E9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198" t="4788" r="28640" b="34750"/>
          <a:stretch>
            <a:fillRect/>
          </a:stretch>
        </p:blipFill>
        <p:spPr>
          <a:xfrm>
            <a:off x="1251858" y="859969"/>
            <a:ext cx="4288972" cy="481709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83FC19E-E675-40BE-12B1-DA884135F3E2}"/>
              </a:ext>
            </a:extLst>
          </p:cNvPr>
          <p:cNvSpPr txBox="1"/>
          <p:nvPr/>
        </p:nvSpPr>
        <p:spPr>
          <a:xfrm>
            <a:off x="1545771" y="1099457"/>
            <a:ext cx="42889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     2     3       4     5       6     7      8      9    10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C8BFB5D-8D9E-B2FC-9774-EF4CBD4764A3}"/>
              </a:ext>
            </a:extLst>
          </p:cNvPr>
          <p:cNvSpPr txBox="1"/>
          <p:nvPr/>
        </p:nvSpPr>
        <p:spPr>
          <a:xfrm>
            <a:off x="1398815" y="3244334"/>
            <a:ext cx="42889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11   12   13    14  15   16   17    18    19    20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2D16384-035A-5FD6-5F2D-07B508C8C8DD}"/>
              </a:ext>
            </a:extLst>
          </p:cNvPr>
          <p:cNvSpPr txBox="1"/>
          <p:nvPr/>
        </p:nvSpPr>
        <p:spPr>
          <a:xfrm>
            <a:off x="6951216" y="1171852"/>
            <a:ext cx="3442528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- C1, 3-C2, 4-C3,</a:t>
            </a:r>
          </a:p>
          <a:p>
            <a:r>
              <a:rPr lang="en-US" dirty="0"/>
              <a:t>5-CO1,6-CO2,7-CO3,</a:t>
            </a:r>
          </a:p>
          <a:p>
            <a:r>
              <a:rPr lang="en-US" dirty="0"/>
              <a:t>8-T1,9-T2,10-T3,</a:t>
            </a:r>
          </a:p>
          <a:p>
            <a:r>
              <a:rPr lang="en-US" dirty="0"/>
              <a:t>12-T1-1,13-T1-2,14-T1-3,</a:t>
            </a:r>
          </a:p>
          <a:p>
            <a:r>
              <a:rPr lang="en-US" dirty="0"/>
              <a:t>15-T2-1,16-T2-2,17-T2-3,</a:t>
            </a:r>
          </a:p>
          <a:p>
            <a:r>
              <a:rPr lang="en-US" dirty="0"/>
              <a:t>18-T3-1,19-T3-2,10-T3-3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E6C5839-8953-F957-4B1C-5CC45A44261B}"/>
              </a:ext>
            </a:extLst>
          </p:cNvPr>
          <p:cNvSpPr txBox="1"/>
          <p:nvPr/>
        </p:nvSpPr>
        <p:spPr>
          <a:xfrm>
            <a:off x="749808" y="265176"/>
            <a:ext cx="44074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Chandler –Total RNA: 1% agarose gel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3327787-03C3-2DC8-A258-8CA27986EED9}"/>
              </a:ext>
            </a:extLst>
          </p:cNvPr>
          <p:cNvSpPr txBox="1"/>
          <p:nvPr/>
        </p:nvSpPr>
        <p:spPr>
          <a:xfrm>
            <a:off x="541367" y="5916548"/>
            <a:ext cx="1137077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kern="1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RNA integration and DNA contamination were assessed using agarose gel electrophoresi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243597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EB7FA2D5-F8C3-BB81-052D-3C44EE0CB110}"/>
              </a:ext>
            </a:extLst>
          </p:cNvPr>
          <p:cNvGrpSpPr/>
          <p:nvPr/>
        </p:nvGrpSpPr>
        <p:grpSpPr>
          <a:xfrm>
            <a:off x="1557200" y="0"/>
            <a:ext cx="5465392" cy="6325281"/>
            <a:chOff x="1557200" y="266359"/>
            <a:chExt cx="5465392" cy="6325281"/>
          </a:xfrm>
        </p:grpSpPr>
        <p:pic>
          <p:nvPicPr>
            <p:cNvPr id="5" name="Picture 4" descr="A white sheet with black lines&#10;&#10;AI-generated content may be incorrect.">
              <a:extLst>
                <a:ext uri="{FF2B5EF4-FFF2-40B4-BE49-F238E27FC236}">
                  <a16:creationId xmlns:a16="http://schemas.microsoft.com/office/drawing/2014/main" id="{3C1F2A11-6ED5-8E06-AEB0-4BD4A1A32E9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042" t="2504" r="25468" b="21081"/>
            <a:stretch>
              <a:fillRect/>
            </a:stretch>
          </p:blipFill>
          <p:spPr>
            <a:xfrm>
              <a:off x="1557200" y="266359"/>
              <a:ext cx="5465392" cy="6325281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FB68D2AD-DA43-D8B2-8C47-73C0D24254F0}"/>
                </a:ext>
              </a:extLst>
            </p:cNvPr>
            <p:cNvSpPr txBox="1"/>
            <p:nvPr/>
          </p:nvSpPr>
          <p:spPr>
            <a:xfrm>
              <a:off x="1557200" y="393793"/>
              <a:ext cx="546539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1    2     3    4   5    6   7    8    9 10 11 12 13  14 15 16  17 18 19  20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B7EC5183-287F-632B-650F-3D8CF05B295C}"/>
                </a:ext>
              </a:extLst>
            </p:cNvPr>
            <p:cNvSpPr txBox="1"/>
            <p:nvPr/>
          </p:nvSpPr>
          <p:spPr>
            <a:xfrm>
              <a:off x="1557200" y="3409954"/>
              <a:ext cx="24998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  21   22  23   24   25 </a:t>
              </a:r>
            </a:p>
          </p:txBody>
        </p: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99D36C40-7C3B-278D-C15D-50D3C1412991}"/>
              </a:ext>
            </a:extLst>
          </p:cNvPr>
          <p:cNvSpPr txBox="1"/>
          <p:nvPr/>
        </p:nvSpPr>
        <p:spPr>
          <a:xfrm>
            <a:off x="7723574" y="1233997"/>
            <a:ext cx="4003828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 -3 – FaARSB-1</a:t>
            </a:r>
          </a:p>
          <a:p>
            <a:r>
              <a:rPr lang="en-US" dirty="0"/>
              <a:t>4 – Negative control (FaARSB-1)</a:t>
            </a:r>
          </a:p>
          <a:p>
            <a:r>
              <a:rPr lang="en-US" dirty="0"/>
              <a:t>5-7 -  FaARSB-2</a:t>
            </a:r>
          </a:p>
          <a:p>
            <a:r>
              <a:rPr lang="en-US" dirty="0"/>
              <a:t>8– Negative control (FaARSB-2)</a:t>
            </a:r>
          </a:p>
          <a:p>
            <a:r>
              <a:rPr lang="en-US" dirty="0"/>
              <a:t>9 – 100bp ladder</a:t>
            </a:r>
          </a:p>
          <a:p>
            <a:r>
              <a:rPr lang="en-US" dirty="0"/>
              <a:t>10- 12 – FaNIP2-1-1</a:t>
            </a:r>
          </a:p>
          <a:p>
            <a:r>
              <a:rPr lang="en-US" dirty="0"/>
              <a:t>13 - Negative control (FaNIP2-1-1)</a:t>
            </a:r>
          </a:p>
          <a:p>
            <a:r>
              <a:rPr lang="en-US" dirty="0"/>
              <a:t>14- 16 – FaNIP2-1-2</a:t>
            </a:r>
          </a:p>
          <a:p>
            <a:r>
              <a:rPr lang="en-US" dirty="0"/>
              <a:t>17 - Negative control (FaNIP2-1-2)</a:t>
            </a:r>
          </a:p>
          <a:p>
            <a:r>
              <a:rPr lang="en-US" dirty="0"/>
              <a:t>18 - 100bp ladder</a:t>
            </a:r>
          </a:p>
          <a:p>
            <a:r>
              <a:rPr lang="en-US" dirty="0"/>
              <a:t>21 -100bp ladder</a:t>
            </a:r>
          </a:p>
          <a:p>
            <a:r>
              <a:rPr lang="en-US" dirty="0"/>
              <a:t>23-25 -&gt; 26S-18S- housekeeping gen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6B6B46F-7A18-15C5-6313-D8E2917FB8A3}"/>
              </a:ext>
            </a:extLst>
          </p:cNvPr>
          <p:cNvSpPr txBox="1"/>
          <p:nvPr/>
        </p:nvSpPr>
        <p:spPr>
          <a:xfrm>
            <a:off x="7794594" y="563070"/>
            <a:ext cx="360433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cDNA – PCR-C1,C2,C3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D2FF11B-8B10-484A-034A-90D154058F6D}"/>
              </a:ext>
            </a:extLst>
          </p:cNvPr>
          <p:cNvSpPr txBox="1"/>
          <p:nvPr/>
        </p:nvSpPr>
        <p:spPr>
          <a:xfrm>
            <a:off x="810088" y="6273225"/>
            <a:ext cx="891540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600" kern="1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DNA contamination was assessed using semiquantitative RT-PCR with gene-specific and housekeeping gene primers; no RT was used as a negative control. 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40410577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3</TotalTime>
  <Words>174</Words>
  <Application>Microsoft Office PowerPoint</Application>
  <PresentationFormat>Widescreen</PresentationFormat>
  <Paragraphs>2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urya Krishna Sakthivel</dc:creator>
  <cp:lastModifiedBy>Amaranatha Vennapusa</cp:lastModifiedBy>
  <cp:revision>4</cp:revision>
  <dcterms:created xsi:type="dcterms:W3CDTF">2025-11-09T20:41:23Z</dcterms:created>
  <dcterms:modified xsi:type="dcterms:W3CDTF">2025-11-10T15:35:38Z</dcterms:modified>
</cp:coreProperties>
</file>